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ish R Maskey" userId="2c4b19f3-a53b-432e-b789-095f8be43390" providerId="ADAL" clId="{78A2D5EF-6817-4CC4-942C-9D388BF8C546}"/>
    <pc:docChg chg="modSld">
      <pc:chgData name="Anish R Maskey" userId="2c4b19f3-a53b-432e-b789-095f8be43390" providerId="ADAL" clId="{78A2D5EF-6817-4CC4-942C-9D388BF8C546}" dt="2024-09-25T20:22:55.965" v="19" actId="20577"/>
      <pc:docMkLst>
        <pc:docMk/>
      </pc:docMkLst>
      <pc:sldChg chg="modSp mod">
        <pc:chgData name="Anish R Maskey" userId="2c4b19f3-a53b-432e-b789-095f8be43390" providerId="ADAL" clId="{78A2D5EF-6817-4CC4-942C-9D388BF8C546}" dt="2024-09-25T20:22:55.965" v="19" actId="20577"/>
        <pc:sldMkLst>
          <pc:docMk/>
          <pc:sldMk cId="1107816399" sldId="260"/>
        </pc:sldMkLst>
        <pc:spChg chg="mod">
          <ac:chgData name="Anish R Maskey" userId="2c4b19f3-a53b-432e-b789-095f8be43390" providerId="ADAL" clId="{78A2D5EF-6817-4CC4-942C-9D388BF8C546}" dt="2024-09-25T20:22:55.965" v="19" actId="20577"/>
          <ac:spMkLst>
            <pc:docMk/>
            <pc:sldMk cId="1107816399" sldId="260"/>
            <ac:spMk id="5" creationId="{3F0D940C-83A4-A2ED-7298-B2D7CEEC2D4E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5C5AE1-A719-644E-1C61-6DB04FEF12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8F0C27-51F4-993C-620E-992F56948E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A26663-403A-3D24-9283-62EBC8FF9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79FAE4-5594-339D-72D5-561F0BCCF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6E2C37-0F1C-8806-EE72-23F239180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0922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A58495-AF8D-75BA-B07F-9AAD6378B1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82F1A5F-3788-44F9-8705-A70287DB15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EE635B-14E2-2188-15E5-3853CA3CA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6B77-FEF3-539C-B8A1-E3652DF49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CBDAC7-0E31-DEDA-33EB-CE278B780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886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784F73-8860-314C-7692-EA7582E298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85BADB-12B3-7819-E598-8BAC66A6B1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4506FC-AFA5-0653-EA25-CFF4CFB99A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D7B46A-F691-2F42-1AA9-AC45DB014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11431F-3020-FF94-459D-5AC7EECCD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911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FB645E-8AF7-854E-EF56-A5AFF754E4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79D5E7-2312-A03E-7CF8-0D1057C42A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1D15A3-8AC5-B681-103E-A8DB06FA72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06A37B-BF50-9CB2-356C-1BC2D70C9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ED7B94-359B-9386-275C-07D91FE7A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127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96E0FC-5F5D-7365-45C2-FF932AC691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69ABF5-0064-1B03-F808-F018001ACB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426195-F9E2-ABCE-12DB-E44BA69B1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CFAD0F-B98A-085D-A005-657F85C9C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A60D36-72E2-31BC-613C-371E87E5F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2159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9E4A36-B14A-3033-7F1D-342A987D63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845750-097F-828C-8FEB-2147338925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E9F111-BD6A-064B-80A5-DB8CA16BE6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99A65A-DEA8-894C-6A4E-EE4E1139DE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4AF2395-DFE7-61AC-15EE-501A952FD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E458625-A160-9C5A-ADAA-F09EE7B829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265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D8E51-D261-0348-A320-8BBC5936F3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EDA3B2-A898-5CB0-0D02-4C60D3798D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F88752-1480-7A43-EE4B-6B8AA5BA3A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7DC2C58-1D49-4FCE-1212-92CA6BFB98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BFC642-BFFE-8556-DBEB-28A3F6412D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47B2715-C83F-3042-1C13-103A333963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F142E83-9913-15D8-1460-21B267BEE0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9152C59-31BD-0A87-67A4-7A39EEBAC1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8192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5889B0-8B74-D32B-2BB3-426F31CD10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4B9F75-6640-B74E-BB94-75C0C7312A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4BD501A-1A6C-7707-3556-7ECCD3EB9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ECF75B-17AD-CF1E-DE56-7A4D12B78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7487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4BC6946-2A66-2BCB-F869-5904E51CC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BB0A5E4-2907-B76B-9A1C-C41E67901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3E8E9F-DDBB-659D-F1BA-B2CC77DBC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893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7CBDA1-769A-DEED-54B6-8BE12E92F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DAC1F8-51D1-0D38-AD58-4A36A17953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5471B9-2222-A07B-BBD1-2A5845C87B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00E0F1-6838-15E8-4761-52EFEE08D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6726D8-2DF6-9A12-45A5-E6DACF7A2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025363-E65A-FD2A-868B-71A5AA318B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655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B6C269-341B-DDEE-E4FD-7AC2AE3775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9C1F03-0DE5-C88B-285D-E520999A03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68ECB9-3051-A537-B38B-9EC908A914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10246F-C961-7D1D-34E9-632FC7014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FAD8D9-2F36-319A-C766-69ED36D45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48C144-484D-4BCE-C6E7-A552C0B14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759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7CDDA88-FFDE-4A65-C6DF-5B289EE401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DC81BD-DA13-E12D-259F-110FF31C54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D57E2A-08EB-4454-05B6-C240B437442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DD9AF10-6CE6-4204-929D-0E369DD49E01}" type="datetimeFigureOut">
              <a:rPr lang="en-US" smtClean="0"/>
              <a:t>9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3D860F-8941-B83B-EDDF-4B3302F6B5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4E54AB-18FD-55FB-8D70-0F7B2BDCBC9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F1DD34-0219-4752-BCBA-BB82FB6F31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948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B1C138-E614-6FC7-35B8-BD12EAAD22B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Information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3D5D40-1F82-84A0-704C-2A6D8DE28AF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Cells- 3195953</a:t>
            </a:r>
          </a:p>
        </p:txBody>
      </p:sp>
    </p:spTree>
    <p:extLst>
      <p:ext uri="{BB962C8B-B14F-4D97-AF65-F5344CB8AC3E}">
        <p14:creationId xmlns:p14="http://schemas.microsoft.com/office/powerpoint/2010/main" val="22608761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4" name="Table 3">
                <a:extLst>
                  <a:ext uri="{FF2B5EF4-FFF2-40B4-BE49-F238E27FC236}">
                    <a16:creationId xmlns:a16="http://schemas.microsoft.com/office/drawing/2014/main" id="{26723654-BC70-128A-B503-F035423FAFF8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3797595524"/>
                  </p:ext>
                </p:extLst>
              </p:nvPr>
            </p:nvGraphicFramePr>
            <p:xfrm>
              <a:off x="262418" y="1357746"/>
              <a:ext cx="6474534" cy="3592497"/>
            </p:xfrm>
            <a:graphic>
              <a:graphicData uri="http://schemas.openxmlformats.org/drawingml/2006/table">
                <a:tbl>
                  <a:tblPr firstRow="1" bandRow="1">
                    <a:tableStyleId>{2D5ABB26-0587-4C30-8999-92F81FD0307C}</a:tableStyleId>
                  </a:tblPr>
                  <a:tblGrid>
                    <a:gridCol w="910774">
                      <a:extLst>
                        <a:ext uri="{9D8B030D-6E8A-4147-A177-3AD203B41FA5}">
                          <a16:colId xmlns:a16="http://schemas.microsoft.com/office/drawing/2014/main" val="610273246"/>
                        </a:ext>
                      </a:extLst>
                    </a:gridCol>
                    <a:gridCol w="2760453">
                      <a:extLst>
                        <a:ext uri="{9D8B030D-6E8A-4147-A177-3AD203B41FA5}">
                          <a16:colId xmlns:a16="http://schemas.microsoft.com/office/drawing/2014/main" val="1320510229"/>
                        </a:ext>
                      </a:extLst>
                    </a:gridCol>
                    <a:gridCol w="2803307">
                      <a:extLst>
                        <a:ext uri="{9D8B030D-6E8A-4147-A177-3AD203B41FA5}">
                          <a16:colId xmlns:a16="http://schemas.microsoft.com/office/drawing/2014/main" val="1637404316"/>
                        </a:ext>
                      </a:extLst>
                    </a:gridCol>
                  </a:tblGrid>
                  <a:tr h="307153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sz="1400" b="1" dirty="0"/>
                            <a:t>Gene</a:t>
                          </a:r>
                        </a:p>
                      </a:txBody>
                      <a:tcPr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sz="1400" b="1" dirty="0"/>
                            <a:t>Forward (5’ – 3’)</a:t>
                          </a:r>
                        </a:p>
                      </a:txBody>
                      <a:tcPr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sz="1400" b="1" dirty="0"/>
                            <a:t>Reverse (5’ – 3’)</a:t>
                          </a:r>
                        </a:p>
                      </a:txBody>
                      <a:tcPr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4058567302"/>
                      </a:ext>
                    </a:extLst>
                  </a:tr>
                  <a:tr h="358114">
                    <a:tc>
                      <a:txBody>
                        <a:bodyPr/>
                        <a:lstStyle/>
                        <a:p>
                          <a:r>
                            <a:rPr lang="en-US" sz="1400" i="1" dirty="0" err="1"/>
                            <a:t>hTNF</a:t>
                          </a:r>
                          <a14:m>
                            <m:oMath xmlns:m="http://schemas.openxmlformats.org/officeDocument/2006/math">
                              <m:r>
                                <a:rPr lang="en-US" sz="1400" i="1" smtClean="0">
                                  <a:latin typeface="Cambria Math" panose="02040503050406030204" pitchFamily="18" charset="0"/>
                                </a:rPr>
                                <m:t>𝛼</m:t>
                              </m:r>
                            </m:oMath>
                          </a14:m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CTCTTCTGCCTGCTGCACTTT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TGGGCTACAGGCTTGTCACTC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1218456031"/>
                      </a:ext>
                    </a:extLst>
                  </a:tr>
                  <a:tr h="319177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IL6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TGAACTCCTTCTCCACAAGC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GAAGAGCCCTCAGGCTGGACT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1764413221"/>
                      </a:ext>
                    </a:extLst>
                  </a:tr>
                  <a:tr h="345057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MAPK1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CACCAACCTCTCGTACATCG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TGGCAGTAGGTCTGGTGCTCA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625648027"/>
                      </a:ext>
                    </a:extLst>
                  </a:tr>
                  <a:tr h="284671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AKT1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TGGACTACCTGCACTCGGAG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GTGCCGCAAAAGGTCTTCATG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330371"/>
                      </a:ext>
                    </a:extLst>
                  </a:tr>
                  <a:tr h="350807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CCND1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TGTTCGTGGCCTCTAAGATG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CAGGTTCCACTTGAGCTTGTTC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2212486223"/>
                      </a:ext>
                    </a:extLst>
                  </a:tr>
                  <a:tr h="353683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IL1</a:t>
                          </a:r>
                          <a14:m>
                            <m:oMath xmlns:m="http://schemas.openxmlformats.org/officeDocument/2006/math">
                              <m:r>
                                <a:rPr lang="en-US" sz="1400" i="1" smtClean="0">
                                  <a:latin typeface="Cambria Math" panose="02040503050406030204" pitchFamily="18" charset="0"/>
                                </a:rPr>
                                <m:t>𝛽</m:t>
                              </m:r>
                            </m:oMath>
                          </a14:m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CCACAGACCTTCCAGGAGAAT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GTGCAGTTCAGTGATCGTACAG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2428279671"/>
                      </a:ext>
                    </a:extLst>
                  </a:tr>
                  <a:tr h="310551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MAPK3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AGGGGTCAAAGGTGGAACC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TGCCTTGAT GACGCCGTATT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109061168"/>
                      </a:ext>
                    </a:extLst>
                  </a:tr>
                  <a:tr h="276045">
                    <a:tc>
                      <a:txBody>
                        <a:bodyPr/>
                        <a:lstStyle/>
                        <a:p>
                          <a:r>
                            <a:rPr lang="en-US" sz="1400" i="1" dirty="0" err="1"/>
                            <a:t>hPPAR</a:t>
                          </a:r>
                          <a14:m>
                            <m:oMath xmlns:m="http://schemas.openxmlformats.org/officeDocument/2006/math">
                              <m:r>
                                <a:rPr lang="en-US" sz="1400" i="1" smtClean="0">
                                  <a:latin typeface="Cambria Math" panose="02040503050406030204" pitchFamily="18" charset="0"/>
                                </a:rPr>
                                <m:t>𝛾</m:t>
                              </m:r>
                            </m:oMath>
                          </a14:m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GAGCCTTCCAACTCCCTC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CAAGGCATTTCTGAAACCG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2017235075"/>
                      </a:ext>
                    </a:extLst>
                  </a:tr>
                  <a:tr h="333555">
                    <a:tc>
                      <a:txBody>
                        <a:bodyPr/>
                        <a:lstStyle/>
                        <a:p>
                          <a:r>
                            <a:rPr lang="en-US" sz="1400" i="1" dirty="0">
                              <a:solidFill>
                                <a:schemeClr val="tx1"/>
                              </a:solidFill>
                            </a:rPr>
                            <a:t>hPTGS2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b="0" i="1" kern="1200" dirty="0">
                              <a:solidFill>
                                <a:schemeClr val="dk1"/>
                              </a:solidFill>
                              <a:effectLst/>
                            </a:rPr>
                            <a:t>CGGTGAAACTCTGGCTAGACAG</a:t>
                          </a:r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b="0" i="1" kern="1200" dirty="0">
                              <a:solidFill>
                                <a:schemeClr val="dk1"/>
                              </a:solidFill>
                              <a:effectLst/>
                            </a:rPr>
                            <a:t>GCAAACCGTAGATGCTCAGGGA</a:t>
                          </a:r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2874680212"/>
                      </a:ext>
                    </a:extLst>
                  </a:tr>
                  <a:tr h="277658">
                    <a:tc>
                      <a:txBody>
                        <a:bodyPr/>
                        <a:lstStyle/>
                        <a:p>
                          <a:r>
                            <a:rPr lang="en-US" sz="1400" i="1" dirty="0">
                              <a:solidFill>
                                <a:schemeClr val="tx1"/>
                              </a:solidFill>
                            </a:rPr>
                            <a:t>hCASP3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b="0" i="1" kern="1200" dirty="0">
                              <a:solidFill>
                                <a:schemeClr val="dk1"/>
                              </a:solidFill>
                              <a:effectLst/>
                            </a:rPr>
                            <a:t>GGAAGCGAATCAATGGACTCTGG</a:t>
                          </a:r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</a:tcPr>
                    </a:tc>
                    <a:tc>
                      <a:txBody>
                        <a:bodyPr/>
                        <a:lstStyle/>
                        <a:p>
                          <a:pPr fontAlgn="ctr"/>
                          <a:r>
                            <a:rPr lang="en-US" sz="1400" i="1" dirty="0">
                              <a:effectLst/>
                            </a:rPr>
                            <a:t>GCATCGACATCTGTACCAGACC</a:t>
                          </a:r>
                        </a:p>
                      </a:txBody>
                      <a:tcPr anchor="ctr"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</a:tcPr>
                    </a:tc>
                    <a:extLst>
                      <a:ext uri="{0D108BD9-81ED-4DB2-BD59-A6C34878D82A}">
                        <a16:rowId xmlns:a16="http://schemas.microsoft.com/office/drawing/2014/main" val="2331685896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4" name="Table 3">
                <a:extLst>
                  <a:ext uri="{FF2B5EF4-FFF2-40B4-BE49-F238E27FC236}">
                    <a16:creationId xmlns:a16="http://schemas.microsoft.com/office/drawing/2014/main" id="{26723654-BC70-128A-B503-F035423FAFF8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3797595524"/>
                  </p:ext>
                </p:extLst>
              </p:nvPr>
            </p:nvGraphicFramePr>
            <p:xfrm>
              <a:off x="262418" y="1357746"/>
              <a:ext cx="6474534" cy="3592497"/>
            </p:xfrm>
            <a:graphic>
              <a:graphicData uri="http://schemas.openxmlformats.org/drawingml/2006/table">
                <a:tbl>
                  <a:tblPr firstRow="1" bandRow="1">
                    <a:tableStyleId>{2D5ABB26-0587-4C30-8999-92F81FD0307C}</a:tableStyleId>
                  </a:tblPr>
                  <a:tblGrid>
                    <a:gridCol w="910774">
                      <a:extLst>
                        <a:ext uri="{9D8B030D-6E8A-4147-A177-3AD203B41FA5}">
                          <a16:colId xmlns:a16="http://schemas.microsoft.com/office/drawing/2014/main" val="610273246"/>
                        </a:ext>
                      </a:extLst>
                    </a:gridCol>
                    <a:gridCol w="2760453">
                      <a:extLst>
                        <a:ext uri="{9D8B030D-6E8A-4147-A177-3AD203B41FA5}">
                          <a16:colId xmlns:a16="http://schemas.microsoft.com/office/drawing/2014/main" val="1320510229"/>
                        </a:ext>
                      </a:extLst>
                    </a:gridCol>
                    <a:gridCol w="2803307">
                      <a:extLst>
                        <a:ext uri="{9D8B030D-6E8A-4147-A177-3AD203B41FA5}">
                          <a16:colId xmlns:a16="http://schemas.microsoft.com/office/drawing/2014/main" val="1637404316"/>
                        </a:ext>
                      </a:extLst>
                    </a:gridCol>
                  </a:tblGrid>
                  <a:tr h="307153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sz="1400" b="1" dirty="0"/>
                            <a:t>Gene</a:t>
                          </a:r>
                        </a:p>
                      </a:txBody>
                      <a:tcPr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sz="1400" b="1" dirty="0"/>
                            <a:t>Forward (5’ – 3’)</a:t>
                          </a:r>
                        </a:p>
                      </a:txBody>
                      <a:tcPr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sz="1400" b="1" dirty="0"/>
                            <a:t>Reverse (5’ – 3’)</a:t>
                          </a:r>
                        </a:p>
                      </a:txBody>
                      <a:tcPr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4058567302"/>
                      </a:ext>
                    </a:extLst>
                  </a:tr>
                  <a:tr h="358114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t="-89655" r="-609333" b="-848276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CTCTTCTGCCTGCTGCACTTT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TGGGCTACAGGCTTGTCACTC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1218456031"/>
                      </a:ext>
                    </a:extLst>
                  </a:tr>
                  <a:tr h="319177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IL6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TGAACTCCTTCTCCACAAGC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GAAGAGCCCTCAGGCTGGACT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1764413221"/>
                      </a:ext>
                    </a:extLst>
                  </a:tr>
                  <a:tr h="345057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MAPK1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CACCAACCTCTCGTACATCG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TGGCAGTAGGTCTGGTGCTCA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625648027"/>
                      </a:ext>
                    </a:extLst>
                  </a:tr>
                  <a:tr h="304800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AKT1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TGGACTACCTGCACTCGGAG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GTGCCGCAAAAGGTCTTCATG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330371"/>
                      </a:ext>
                    </a:extLst>
                  </a:tr>
                  <a:tr h="350807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CCND1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TGTTCGTGGCCTCTAAGATG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CAGGTTCCACTTGAGCTTGTTC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2212486223"/>
                      </a:ext>
                    </a:extLst>
                  </a:tr>
                  <a:tr h="353683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t="-565517" r="-609333" b="-372414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CCACAGACCTTCCAGGAGAAT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GTGCAGTTCAGTGATCGTACAGG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2428279671"/>
                      </a:ext>
                    </a:extLst>
                  </a:tr>
                  <a:tr h="310551"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hMAPK3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AGGGGTCAAAGGTGGAACC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TGCCTTGAT GACGCCGTATT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109061168"/>
                      </a:ext>
                    </a:extLst>
                  </a:tr>
                  <a:tr h="30480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t="-874000" r="-609333" b="-230000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AGAGCCTTCCAACTCCCTC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i="1" dirty="0"/>
                            <a:t>CAAGGCATTTCTGAAACCGA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2017235075"/>
                      </a:ext>
                    </a:extLst>
                  </a:tr>
                  <a:tr h="333555">
                    <a:tc>
                      <a:txBody>
                        <a:bodyPr/>
                        <a:lstStyle/>
                        <a:p>
                          <a:r>
                            <a:rPr lang="en-US" sz="1400" i="1" dirty="0">
                              <a:solidFill>
                                <a:schemeClr val="tx1"/>
                              </a:solidFill>
                            </a:rPr>
                            <a:t>hPTGS2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b="0" i="1" kern="1200" dirty="0">
                              <a:solidFill>
                                <a:schemeClr val="dk1"/>
                              </a:solidFill>
                              <a:effectLst/>
                            </a:rPr>
                            <a:t>CGGTGAAACTCTGGCTAGACAG</a:t>
                          </a:r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b="0" i="1" kern="1200" dirty="0">
                              <a:solidFill>
                                <a:schemeClr val="dk1"/>
                              </a:solidFill>
                              <a:effectLst/>
                            </a:rPr>
                            <a:t>GCAAACCGTAGATGCTCAGGGA</a:t>
                          </a:r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</a:tcPr>
                    </a:tc>
                    <a:extLst>
                      <a:ext uri="{0D108BD9-81ED-4DB2-BD59-A6C34878D82A}">
                        <a16:rowId xmlns:a16="http://schemas.microsoft.com/office/drawing/2014/main" val="2874680212"/>
                      </a:ext>
                    </a:extLst>
                  </a:tr>
                  <a:tr h="304800">
                    <a:tc>
                      <a:txBody>
                        <a:bodyPr/>
                        <a:lstStyle/>
                        <a:p>
                          <a:r>
                            <a:rPr lang="en-US" sz="1400" i="1" dirty="0">
                              <a:solidFill>
                                <a:schemeClr val="tx1"/>
                              </a:solidFill>
                            </a:rPr>
                            <a:t>hCASP3</a:t>
                          </a:r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</a:tcPr>
                    </a:tc>
                    <a:tc>
                      <a:txBody>
                        <a:bodyPr/>
                        <a:lstStyle/>
                        <a:p>
                          <a:r>
                            <a:rPr lang="en-US" sz="1400" b="0" i="1" kern="1200" dirty="0">
                              <a:solidFill>
                                <a:schemeClr val="dk1"/>
                              </a:solidFill>
                              <a:effectLst/>
                            </a:rPr>
                            <a:t>GGAAGCGAATCAATGGACTCTGG</a:t>
                          </a:r>
                          <a:endParaRPr lang="en-US" sz="1400" i="1" dirty="0"/>
                        </a:p>
                      </a:txBody>
                      <a:tcP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</a:tcPr>
                    </a:tc>
                    <a:tc>
                      <a:txBody>
                        <a:bodyPr/>
                        <a:lstStyle/>
                        <a:p>
                          <a:pPr fontAlgn="ctr"/>
                          <a:r>
                            <a:rPr lang="en-US" sz="1400" i="1" dirty="0">
                              <a:effectLst/>
                            </a:rPr>
                            <a:t>GCATCGACATCTGTACCAGACC</a:t>
                          </a:r>
                        </a:p>
                      </a:txBody>
                      <a:tcPr anchor="ctr"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</a:tcPr>
                    </a:tc>
                    <a:extLst>
                      <a:ext uri="{0D108BD9-81ED-4DB2-BD59-A6C34878D82A}">
                        <a16:rowId xmlns:a16="http://schemas.microsoft.com/office/drawing/2014/main" val="2331685896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5" name="TextBox 4">
            <a:extLst>
              <a:ext uri="{FF2B5EF4-FFF2-40B4-BE49-F238E27FC236}">
                <a16:creationId xmlns:a16="http://schemas.microsoft.com/office/drawing/2014/main" id="{CEBED018-253D-7194-3E24-3AC094F1EE7A}"/>
              </a:ext>
            </a:extLst>
          </p:cNvPr>
          <p:cNvSpPr txBox="1"/>
          <p:nvPr/>
        </p:nvSpPr>
        <p:spPr>
          <a:xfrm>
            <a:off x="262418" y="837865"/>
            <a:ext cx="39571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1: Primer sequence</a:t>
            </a:r>
          </a:p>
        </p:txBody>
      </p:sp>
    </p:spTree>
    <p:extLst>
      <p:ext uri="{BB962C8B-B14F-4D97-AF65-F5344CB8AC3E}">
        <p14:creationId xmlns:p14="http://schemas.microsoft.com/office/powerpoint/2010/main" val="31632933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3E85C85-FF04-AEB5-460D-70080E3E59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6700" y="1825297"/>
            <a:ext cx="5829300" cy="218122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45BA09F-2ECB-112D-2108-8766DEC6C903}"/>
              </a:ext>
            </a:extLst>
          </p:cNvPr>
          <p:cNvSpPr txBox="1"/>
          <p:nvPr/>
        </p:nvSpPr>
        <p:spPr>
          <a:xfrm>
            <a:off x="204123" y="4294163"/>
            <a:ext cx="901302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HPLC analysis of BBR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hromatographic graph acquired at wavelength 264nm of BBR (50µg/mL). BBR was dissolved in methanol and loaded on a ZORBAX SB-C18 column for separation. The flow rate was set at 1mL/min. </a:t>
            </a:r>
          </a:p>
        </p:txBody>
      </p:sp>
    </p:spTree>
    <p:extLst>
      <p:ext uri="{BB962C8B-B14F-4D97-AF65-F5344CB8AC3E}">
        <p14:creationId xmlns:p14="http://schemas.microsoft.com/office/powerpoint/2010/main" val="36615054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89501B0-EBFA-7BC8-878E-A53A9A49F05B}"/>
              </a:ext>
            </a:extLst>
          </p:cNvPr>
          <p:cNvSpPr txBox="1"/>
          <p:nvPr/>
        </p:nvSpPr>
        <p:spPr>
          <a:xfrm>
            <a:off x="291037" y="5208563"/>
            <a:ext cx="1160992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Effect of BBR on growth of ATCC 33591 strai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 BBR showed a dose dependent growth inhibitory effect in ATCC #33591 strain. The MIC was 128 </a:t>
            </a:r>
            <a:r>
              <a:rPr lang="el-GR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</a:t>
            </a:r>
            <a:r>
              <a:rPr lang="en-US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L.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represents mean± SD. (N=triplicate culture;; </a:t>
            </a:r>
            <a:r>
              <a:rPr lang="en-US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&lt;0.01; ***p&lt;0.001 vs 0)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847B00E0-C610-D3B5-130B-9184012424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037" y="1923223"/>
            <a:ext cx="3878580" cy="31546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96336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2B5B97B-A6A0-8CAA-6A2F-73122131E8A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601" y="989382"/>
            <a:ext cx="5920740" cy="291846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F0D940C-83A4-A2ED-7298-B2D7CEEC2D4E}"/>
              </a:ext>
            </a:extLst>
          </p:cNvPr>
          <p:cNvSpPr txBox="1"/>
          <p:nvPr/>
        </p:nvSpPr>
        <p:spPr>
          <a:xfrm>
            <a:off x="66341" y="4283767"/>
            <a:ext cx="1219200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Effect of BBR on ROS production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ntracellular reactive oxygen species (ROS) levels were measured using the DCFDA/ H2DCFDA-Cellular ROS assay kit (Abcam, MA) as per the manufacturer's instructions. (A) U937 cells and (B) RAW264.7 cells pre-treated with BBR (20 </a:t>
            </a:r>
            <a:r>
              <a:rPr lang="el-G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mL) and stimulated with ATCC (#33591) HKS (MOI, 1:2) showed reduced ROS production as compared to untreated cells. Data represents mean± SD. (N=triplicate culture; </a:t>
            </a:r>
            <a:r>
              <a:rPr lang="en-US" sz="18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###</a:t>
            </a:r>
            <a:r>
              <a:rPr lang="en-US" sz="18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&lt;0.001 vs untreated; **p&lt;0.0; ***p&lt;0.001 vs HKS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07816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79</Words>
  <Application>Microsoft Office PowerPoint</Application>
  <PresentationFormat>Widescreen</PresentationFormat>
  <Paragraphs>3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ptos</vt:lpstr>
      <vt:lpstr>Aptos Display</vt:lpstr>
      <vt:lpstr>Arial</vt:lpstr>
      <vt:lpstr>Cambria Math</vt:lpstr>
      <vt:lpstr>Times New Roman</vt:lpstr>
      <vt:lpstr>Office Theme</vt:lpstr>
      <vt:lpstr>Supplementary Inform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nish R Maskey</dc:creator>
  <cp:lastModifiedBy>Anish R Maskey</cp:lastModifiedBy>
  <cp:revision>1</cp:revision>
  <dcterms:created xsi:type="dcterms:W3CDTF">2024-09-19T14:58:17Z</dcterms:created>
  <dcterms:modified xsi:type="dcterms:W3CDTF">2024-09-25T20:23:03Z</dcterms:modified>
</cp:coreProperties>
</file>